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5" r:id="rId2"/>
    <p:sldId id="290" r:id="rId3"/>
    <p:sldId id="295" r:id="rId4"/>
    <p:sldId id="299" r:id="rId5"/>
    <p:sldId id="298" r:id="rId6"/>
    <p:sldId id="292" r:id="rId7"/>
    <p:sldId id="291" r:id="rId8"/>
    <p:sldId id="300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E42A"/>
    <a:srgbClr val="FF33CC"/>
    <a:srgbClr val="FFFF2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21371" autoAdjust="0"/>
    <p:restoredTop sz="89451" autoAdjust="0"/>
  </p:normalViewPr>
  <p:slideViewPr>
    <p:cSldViewPr>
      <p:cViewPr>
        <p:scale>
          <a:sx n="66" d="100"/>
          <a:sy n="66" d="100"/>
        </p:scale>
        <p:origin x="-1206" y="-15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D83CAC-BFCB-334C-9348-98A8DB9D1C1D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F5AB8E-5434-EB4E-ACDD-F4D778A6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200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Had said</a:t>
            </a:r>
            <a:r>
              <a:rPr lang="en-US" baseline="0" dirty="0" smtClean="0"/>
              <a:t> to reduce font size, so reduced labels from 14 to 1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943383E-4A60-9947-8730-AE3A9EF4ED3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9002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se</a:t>
            </a:r>
            <a:r>
              <a:rPr lang="en-US" baseline="0" dirty="0" smtClean="0"/>
              <a:t> are values just for 64b I believe, could </a:t>
            </a:r>
            <a:r>
              <a:rPr lang="en-US" dirty="0" smtClean="0"/>
              <a:t>Possibly remove this table and say data not shown</a:t>
            </a:r>
            <a:r>
              <a:rPr lang="en-US" baseline="0" dirty="0" smtClean="0"/>
              <a:t> in text?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AF5AB8E-5434-EB4E-ACDD-F4D778A633C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1832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9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874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169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222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234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676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864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206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286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577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297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66961-AFA8-4651-BB57-D503A9255221}" type="datetimeFigureOut">
              <a:rPr lang="en-US" smtClean="0"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4419B-4C7F-4087-B038-5C8A5237E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394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Round Same Side Corner Rectangle 63"/>
          <p:cNvSpPr/>
          <p:nvPr/>
        </p:nvSpPr>
        <p:spPr>
          <a:xfrm rot="10800000">
            <a:off x="1074267" y="4129914"/>
            <a:ext cx="1014956" cy="913457"/>
          </a:xfrm>
          <a:prstGeom prst="round2SameRect">
            <a:avLst/>
          </a:prstGeom>
          <a:solidFill>
            <a:srgbClr val="FFE42A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67057" y="5657671"/>
            <a:ext cx="88773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S1</a:t>
            </a:r>
            <a:r>
              <a:rPr lang="en-US" b="1" dirty="0"/>
              <a:t>:</a:t>
            </a:r>
            <a:r>
              <a:rPr lang="en-US" b="1" dirty="0" smtClean="0"/>
              <a:t> </a:t>
            </a:r>
            <a:r>
              <a:rPr lang="en-US" b="1" dirty="0"/>
              <a:t>Schematic of MEC system investigating hydrogen production </a:t>
            </a:r>
            <a:r>
              <a:rPr lang="en-US" b="1" dirty="0" smtClean="0"/>
              <a:t>under batch </a:t>
            </a:r>
            <a:r>
              <a:rPr lang="en-US" b="1" dirty="0"/>
              <a:t>conditions. Substrate was added directly into the feed </a:t>
            </a:r>
            <a:r>
              <a:rPr lang="en-US" b="1" dirty="0" smtClean="0"/>
              <a:t>reservoir.</a:t>
            </a:r>
            <a:endParaRPr lang="en-US" b="1" dirty="0"/>
          </a:p>
        </p:txBody>
      </p:sp>
      <p:grpSp>
        <p:nvGrpSpPr>
          <p:cNvPr id="6" name="Group 5"/>
          <p:cNvGrpSpPr/>
          <p:nvPr/>
        </p:nvGrpSpPr>
        <p:grpSpPr>
          <a:xfrm>
            <a:off x="908905" y="88702"/>
            <a:ext cx="7772397" cy="5476221"/>
            <a:chOff x="1395648" y="685799"/>
            <a:chExt cx="6224389" cy="4884833"/>
          </a:xfrm>
        </p:grpSpPr>
        <p:sp>
          <p:nvSpPr>
            <p:cNvPr id="8" name="Rectangle 7"/>
            <p:cNvSpPr/>
            <p:nvPr/>
          </p:nvSpPr>
          <p:spPr>
            <a:xfrm>
              <a:off x="5715028" y="2590802"/>
              <a:ext cx="1905009" cy="304800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ounded Rectangle 8"/>
            <p:cNvSpPr/>
            <p:nvPr/>
          </p:nvSpPr>
          <p:spPr>
            <a:xfrm>
              <a:off x="3911891" y="1588019"/>
              <a:ext cx="45720" cy="457201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4724423" y="3190877"/>
              <a:ext cx="0" cy="757383"/>
            </a:xfrm>
            <a:prstGeom prst="line">
              <a:avLst/>
            </a:prstGeom>
            <a:ln w="6350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Rounded Rectangle 10"/>
            <p:cNvSpPr/>
            <p:nvPr/>
          </p:nvSpPr>
          <p:spPr>
            <a:xfrm>
              <a:off x="1859166" y="3200402"/>
              <a:ext cx="58068" cy="1638301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ounded Rectangle 12"/>
            <p:cNvSpPr/>
            <p:nvPr/>
          </p:nvSpPr>
          <p:spPr>
            <a:xfrm>
              <a:off x="5029225" y="3505202"/>
              <a:ext cx="533403" cy="1157933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rapezoid 13"/>
            <p:cNvSpPr/>
            <p:nvPr/>
          </p:nvSpPr>
          <p:spPr>
            <a:xfrm>
              <a:off x="3295666" y="5172079"/>
              <a:ext cx="190501" cy="85725"/>
            </a:xfrm>
            <a:prstGeom prst="trapezoid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Connector 14"/>
            <p:cNvCxnSpPr/>
            <p:nvPr/>
          </p:nvCxnSpPr>
          <p:spPr>
            <a:xfrm flipH="1">
              <a:off x="5181625" y="2209801"/>
              <a:ext cx="914404" cy="0"/>
            </a:xfrm>
            <a:prstGeom prst="line">
              <a:avLst/>
            </a:prstGeom>
            <a:ln w="3810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6096030" y="2209801"/>
              <a:ext cx="0" cy="595457"/>
            </a:xfrm>
            <a:prstGeom prst="line">
              <a:avLst/>
            </a:prstGeom>
            <a:ln w="3810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flipH="1">
              <a:off x="6096030" y="2805258"/>
              <a:ext cx="524167" cy="0"/>
            </a:xfrm>
            <a:prstGeom prst="line">
              <a:avLst/>
            </a:prstGeom>
            <a:ln w="3810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6626785" y="1093625"/>
              <a:ext cx="2648" cy="1711634"/>
            </a:xfrm>
            <a:prstGeom prst="line">
              <a:avLst/>
            </a:prstGeom>
            <a:ln w="3810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rapezoid 6"/>
            <p:cNvSpPr/>
            <p:nvPr/>
          </p:nvSpPr>
          <p:spPr>
            <a:xfrm rot="10800000">
              <a:off x="6331269" y="685799"/>
              <a:ext cx="602962" cy="304800"/>
            </a:xfrm>
            <a:custGeom>
              <a:avLst/>
              <a:gdLst>
                <a:gd name="connsiteX0" fmla="*/ 0 w 602959"/>
                <a:gd name="connsiteY0" fmla="*/ 304800 h 304800"/>
                <a:gd name="connsiteX1" fmla="*/ 76200 w 602959"/>
                <a:gd name="connsiteY1" fmla="*/ 0 h 304800"/>
                <a:gd name="connsiteX2" fmla="*/ 526759 w 602959"/>
                <a:gd name="connsiteY2" fmla="*/ 0 h 304800"/>
                <a:gd name="connsiteX3" fmla="*/ 602959 w 602959"/>
                <a:gd name="connsiteY3" fmla="*/ 304800 h 304800"/>
                <a:gd name="connsiteX4" fmla="*/ 0 w 602959"/>
                <a:gd name="connsiteY4" fmla="*/ 304800 h 304800"/>
                <a:gd name="connsiteX0" fmla="*/ 0 w 602959"/>
                <a:gd name="connsiteY0" fmla="*/ 304800 h 304800"/>
                <a:gd name="connsiteX1" fmla="*/ 113146 w 602959"/>
                <a:gd name="connsiteY1" fmla="*/ 0 h 304800"/>
                <a:gd name="connsiteX2" fmla="*/ 526759 w 602959"/>
                <a:gd name="connsiteY2" fmla="*/ 0 h 304800"/>
                <a:gd name="connsiteX3" fmla="*/ 602959 w 602959"/>
                <a:gd name="connsiteY3" fmla="*/ 304800 h 304800"/>
                <a:gd name="connsiteX4" fmla="*/ 0 w 602959"/>
                <a:gd name="connsiteY4" fmla="*/ 304800 h 304800"/>
                <a:gd name="connsiteX0" fmla="*/ 0 w 602959"/>
                <a:gd name="connsiteY0" fmla="*/ 304800 h 304800"/>
                <a:gd name="connsiteX1" fmla="*/ 113146 w 602959"/>
                <a:gd name="connsiteY1" fmla="*/ 0 h 304800"/>
                <a:gd name="connsiteX2" fmla="*/ 526759 w 602959"/>
                <a:gd name="connsiteY2" fmla="*/ 0 h 304800"/>
                <a:gd name="connsiteX3" fmla="*/ 602959 w 602959"/>
                <a:gd name="connsiteY3" fmla="*/ 304800 h 304800"/>
                <a:gd name="connsiteX4" fmla="*/ 0 w 602959"/>
                <a:gd name="connsiteY4" fmla="*/ 304800 h 304800"/>
                <a:gd name="connsiteX0" fmla="*/ 0 w 602959"/>
                <a:gd name="connsiteY0" fmla="*/ 304800 h 304800"/>
                <a:gd name="connsiteX1" fmla="*/ 113146 w 602959"/>
                <a:gd name="connsiteY1" fmla="*/ 0 h 304800"/>
                <a:gd name="connsiteX2" fmla="*/ 489814 w 602959"/>
                <a:gd name="connsiteY2" fmla="*/ 0 h 304800"/>
                <a:gd name="connsiteX3" fmla="*/ 602959 w 602959"/>
                <a:gd name="connsiteY3" fmla="*/ 304800 h 304800"/>
                <a:gd name="connsiteX4" fmla="*/ 0 w 602959"/>
                <a:gd name="connsiteY4" fmla="*/ 304800 h 304800"/>
                <a:gd name="connsiteX0" fmla="*/ 0 w 602959"/>
                <a:gd name="connsiteY0" fmla="*/ 304800 h 304800"/>
                <a:gd name="connsiteX1" fmla="*/ 113146 w 602959"/>
                <a:gd name="connsiteY1" fmla="*/ 0 h 304800"/>
                <a:gd name="connsiteX2" fmla="*/ 489814 w 602959"/>
                <a:gd name="connsiteY2" fmla="*/ 0 h 304800"/>
                <a:gd name="connsiteX3" fmla="*/ 602959 w 602959"/>
                <a:gd name="connsiteY3" fmla="*/ 304800 h 304800"/>
                <a:gd name="connsiteX4" fmla="*/ 0 w 602959"/>
                <a:gd name="connsiteY4" fmla="*/ 304800 h 304800"/>
                <a:gd name="connsiteX0" fmla="*/ 0 w 602959"/>
                <a:gd name="connsiteY0" fmla="*/ 304800 h 304800"/>
                <a:gd name="connsiteX1" fmla="*/ 113146 w 602959"/>
                <a:gd name="connsiteY1" fmla="*/ 0 h 304800"/>
                <a:gd name="connsiteX2" fmla="*/ 517523 w 602959"/>
                <a:gd name="connsiteY2" fmla="*/ 0 h 304800"/>
                <a:gd name="connsiteX3" fmla="*/ 602959 w 602959"/>
                <a:gd name="connsiteY3" fmla="*/ 304800 h 304800"/>
                <a:gd name="connsiteX4" fmla="*/ 0 w 602959"/>
                <a:gd name="connsiteY4" fmla="*/ 304800 h 304800"/>
                <a:gd name="connsiteX0" fmla="*/ 0 w 602959"/>
                <a:gd name="connsiteY0" fmla="*/ 304800 h 304800"/>
                <a:gd name="connsiteX1" fmla="*/ 113146 w 602959"/>
                <a:gd name="connsiteY1" fmla="*/ 0 h 304800"/>
                <a:gd name="connsiteX2" fmla="*/ 517523 w 602959"/>
                <a:gd name="connsiteY2" fmla="*/ 0 h 304800"/>
                <a:gd name="connsiteX3" fmla="*/ 519542 w 602959"/>
                <a:gd name="connsiteY3" fmla="*/ 143163 h 304800"/>
                <a:gd name="connsiteX4" fmla="*/ 602959 w 602959"/>
                <a:gd name="connsiteY4" fmla="*/ 304800 h 304800"/>
                <a:gd name="connsiteX5" fmla="*/ 0 w 602959"/>
                <a:gd name="connsiteY5" fmla="*/ 304800 h 304800"/>
                <a:gd name="connsiteX0" fmla="*/ 0 w 602959"/>
                <a:gd name="connsiteY0" fmla="*/ 304800 h 304800"/>
                <a:gd name="connsiteX1" fmla="*/ 113146 w 602959"/>
                <a:gd name="connsiteY1" fmla="*/ 0 h 304800"/>
                <a:gd name="connsiteX2" fmla="*/ 517523 w 602959"/>
                <a:gd name="connsiteY2" fmla="*/ 0 h 304800"/>
                <a:gd name="connsiteX3" fmla="*/ 556488 w 602959"/>
                <a:gd name="connsiteY3" fmla="*/ 143163 h 304800"/>
                <a:gd name="connsiteX4" fmla="*/ 602959 w 602959"/>
                <a:gd name="connsiteY4" fmla="*/ 304800 h 304800"/>
                <a:gd name="connsiteX5" fmla="*/ 0 w 602959"/>
                <a:gd name="connsiteY5" fmla="*/ 304800 h 304800"/>
                <a:gd name="connsiteX0" fmla="*/ 0 w 602959"/>
                <a:gd name="connsiteY0" fmla="*/ 304800 h 304800"/>
                <a:gd name="connsiteX1" fmla="*/ 113146 w 602959"/>
                <a:gd name="connsiteY1" fmla="*/ 0 h 304800"/>
                <a:gd name="connsiteX2" fmla="*/ 517523 w 602959"/>
                <a:gd name="connsiteY2" fmla="*/ 0 h 304800"/>
                <a:gd name="connsiteX3" fmla="*/ 519542 w 602959"/>
                <a:gd name="connsiteY3" fmla="*/ 161636 h 304800"/>
                <a:gd name="connsiteX4" fmla="*/ 602959 w 602959"/>
                <a:gd name="connsiteY4" fmla="*/ 304800 h 304800"/>
                <a:gd name="connsiteX5" fmla="*/ 0 w 602959"/>
                <a:gd name="connsiteY5" fmla="*/ 304800 h 304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602959" h="304800">
                  <a:moveTo>
                    <a:pt x="0" y="304800"/>
                  </a:moveTo>
                  <a:cubicBezTo>
                    <a:pt x="37715" y="203200"/>
                    <a:pt x="121613" y="166254"/>
                    <a:pt x="113146" y="0"/>
                  </a:cubicBezTo>
                  <a:lnTo>
                    <a:pt x="517523" y="0"/>
                  </a:lnTo>
                  <a:cubicBezTo>
                    <a:pt x="524354" y="32327"/>
                    <a:pt x="512711" y="129309"/>
                    <a:pt x="519542" y="161636"/>
                  </a:cubicBezTo>
                  <a:lnTo>
                    <a:pt x="602959" y="304800"/>
                  </a:lnTo>
                  <a:lnTo>
                    <a:pt x="0" y="304800"/>
                  </a:lnTo>
                  <a:close/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ounded Rectangle 9"/>
            <p:cNvSpPr/>
            <p:nvPr/>
          </p:nvSpPr>
          <p:spPr>
            <a:xfrm>
              <a:off x="6401999" y="1318202"/>
              <a:ext cx="413303" cy="1416628"/>
            </a:xfrm>
            <a:custGeom>
              <a:avLst/>
              <a:gdLst>
                <a:gd name="connsiteX0" fmla="*/ 0 w 390524"/>
                <a:gd name="connsiteY0" fmla="*/ 65089 h 1407391"/>
                <a:gd name="connsiteX1" fmla="*/ 65089 w 390524"/>
                <a:gd name="connsiteY1" fmla="*/ 0 h 1407391"/>
                <a:gd name="connsiteX2" fmla="*/ 325435 w 390524"/>
                <a:gd name="connsiteY2" fmla="*/ 0 h 1407391"/>
                <a:gd name="connsiteX3" fmla="*/ 390524 w 390524"/>
                <a:gd name="connsiteY3" fmla="*/ 65089 h 1407391"/>
                <a:gd name="connsiteX4" fmla="*/ 390524 w 390524"/>
                <a:gd name="connsiteY4" fmla="*/ 1342302 h 1407391"/>
                <a:gd name="connsiteX5" fmla="*/ 325435 w 390524"/>
                <a:gd name="connsiteY5" fmla="*/ 1407391 h 1407391"/>
                <a:gd name="connsiteX6" fmla="*/ 65089 w 390524"/>
                <a:gd name="connsiteY6" fmla="*/ 1407391 h 1407391"/>
                <a:gd name="connsiteX7" fmla="*/ 0 w 390524"/>
                <a:gd name="connsiteY7" fmla="*/ 1342302 h 1407391"/>
                <a:gd name="connsiteX8" fmla="*/ 0 w 390524"/>
                <a:gd name="connsiteY8" fmla="*/ 65089 h 1407391"/>
                <a:gd name="connsiteX0" fmla="*/ 0 w 390524"/>
                <a:gd name="connsiteY0" fmla="*/ 65089 h 1407391"/>
                <a:gd name="connsiteX1" fmla="*/ 65089 w 390524"/>
                <a:gd name="connsiteY1" fmla="*/ 0 h 1407391"/>
                <a:gd name="connsiteX2" fmla="*/ 325435 w 390524"/>
                <a:gd name="connsiteY2" fmla="*/ 0 h 1407391"/>
                <a:gd name="connsiteX3" fmla="*/ 390524 w 390524"/>
                <a:gd name="connsiteY3" fmla="*/ 65089 h 1407391"/>
                <a:gd name="connsiteX4" fmla="*/ 390524 w 390524"/>
                <a:gd name="connsiteY4" fmla="*/ 1342302 h 1407391"/>
                <a:gd name="connsiteX5" fmla="*/ 325435 w 390524"/>
                <a:gd name="connsiteY5" fmla="*/ 1407391 h 1407391"/>
                <a:gd name="connsiteX6" fmla="*/ 212435 w 390524"/>
                <a:gd name="connsiteY6" fmla="*/ 1348798 h 1407391"/>
                <a:gd name="connsiteX7" fmla="*/ 65089 w 390524"/>
                <a:gd name="connsiteY7" fmla="*/ 1407391 h 1407391"/>
                <a:gd name="connsiteX8" fmla="*/ 0 w 390524"/>
                <a:gd name="connsiteY8" fmla="*/ 1342302 h 1407391"/>
                <a:gd name="connsiteX9" fmla="*/ 0 w 390524"/>
                <a:gd name="connsiteY9" fmla="*/ 65089 h 1407391"/>
                <a:gd name="connsiteX0" fmla="*/ 22777 w 413301"/>
                <a:gd name="connsiteY0" fmla="*/ 65089 h 1416627"/>
                <a:gd name="connsiteX1" fmla="*/ 87866 w 413301"/>
                <a:gd name="connsiteY1" fmla="*/ 0 h 1416627"/>
                <a:gd name="connsiteX2" fmla="*/ 348212 w 413301"/>
                <a:gd name="connsiteY2" fmla="*/ 0 h 1416627"/>
                <a:gd name="connsiteX3" fmla="*/ 413301 w 413301"/>
                <a:gd name="connsiteY3" fmla="*/ 65089 h 1416627"/>
                <a:gd name="connsiteX4" fmla="*/ 413301 w 413301"/>
                <a:gd name="connsiteY4" fmla="*/ 1342302 h 1416627"/>
                <a:gd name="connsiteX5" fmla="*/ 348212 w 413301"/>
                <a:gd name="connsiteY5" fmla="*/ 1407391 h 1416627"/>
                <a:gd name="connsiteX6" fmla="*/ 235212 w 413301"/>
                <a:gd name="connsiteY6" fmla="*/ 1348798 h 1416627"/>
                <a:gd name="connsiteX7" fmla="*/ 13975 w 413301"/>
                <a:gd name="connsiteY7" fmla="*/ 1416627 h 1416627"/>
                <a:gd name="connsiteX8" fmla="*/ 22777 w 413301"/>
                <a:gd name="connsiteY8" fmla="*/ 1342302 h 1416627"/>
                <a:gd name="connsiteX9" fmla="*/ 22777 w 413301"/>
                <a:gd name="connsiteY9" fmla="*/ 65089 h 1416627"/>
                <a:gd name="connsiteX0" fmla="*/ 22777 w 413301"/>
                <a:gd name="connsiteY0" fmla="*/ 65089 h 1416627"/>
                <a:gd name="connsiteX1" fmla="*/ 87866 w 413301"/>
                <a:gd name="connsiteY1" fmla="*/ 0 h 1416627"/>
                <a:gd name="connsiteX2" fmla="*/ 348212 w 413301"/>
                <a:gd name="connsiteY2" fmla="*/ 0 h 1416627"/>
                <a:gd name="connsiteX3" fmla="*/ 413301 w 413301"/>
                <a:gd name="connsiteY3" fmla="*/ 65089 h 1416627"/>
                <a:gd name="connsiteX4" fmla="*/ 413301 w 413301"/>
                <a:gd name="connsiteY4" fmla="*/ 1342302 h 1416627"/>
                <a:gd name="connsiteX5" fmla="*/ 348212 w 413301"/>
                <a:gd name="connsiteY5" fmla="*/ 1407391 h 1416627"/>
                <a:gd name="connsiteX6" fmla="*/ 235212 w 413301"/>
                <a:gd name="connsiteY6" fmla="*/ 1376507 h 1416627"/>
                <a:gd name="connsiteX7" fmla="*/ 13975 w 413301"/>
                <a:gd name="connsiteY7" fmla="*/ 1416627 h 1416627"/>
                <a:gd name="connsiteX8" fmla="*/ 22777 w 413301"/>
                <a:gd name="connsiteY8" fmla="*/ 1342302 h 1416627"/>
                <a:gd name="connsiteX9" fmla="*/ 22777 w 413301"/>
                <a:gd name="connsiteY9" fmla="*/ 65089 h 14166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413301" h="1416627">
                  <a:moveTo>
                    <a:pt x="22777" y="65089"/>
                  </a:moveTo>
                  <a:cubicBezTo>
                    <a:pt x="22777" y="29141"/>
                    <a:pt x="51918" y="0"/>
                    <a:pt x="87866" y="0"/>
                  </a:cubicBezTo>
                  <a:lnTo>
                    <a:pt x="348212" y="0"/>
                  </a:lnTo>
                  <a:cubicBezTo>
                    <a:pt x="384160" y="0"/>
                    <a:pt x="413301" y="29141"/>
                    <a:pt x="413301" y="65089"/>
                  </a:cubicBezTo>
                  <a:lnTo>
                    <a:pt x="413301" y="1342302"/>
                  </a:lnTo>
                  <a:cubicBezTo>
                    <a:pt x="413301" y="1378250"/>
                    <a:pt x="384160" y="1407391"/>
                    <a:pt x="348212" y="1407391"/>
                  </a:cubicBezTo>
                  <a:cubicBezTo>
                    <a:pt x="310545" y="1403254"/>
                    <a:pt x="272879" y="1380644"/>
                    <a:pt x="235212" y="1376507"/>
                  </a:cubicBezTo>
                  <a:cubicBezTo>
                    <a:pt x="186097" y="1380644"/>
                    <a:pt x="63090" y="1412490"/>
                    <a:pt x="13975" y="1416627"/>
                  </a:cubicBezTo>
                  <a:cubicBezTo>
                    <a:pt x="-21973" y="1416627"/>
                    <a:pt x="22777" y="1378250"/>
                    <a:pt x="22777" y="1342302"/>
                  </a:cubicBezTo>
                  <a:lnTo>
                    <a:pt x="22777" y="65089"/>
                  </a:lnTo>
                  <a:close/>
                </a:path>
              </a:pathLst>
            </a:custGeom>
            <a:solidFill>
              <a:schemeClr val="tx2">
                <a:lumMod val="40000"/>
                <a:lumOff val="60000"/>
                <a:alpha val="69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Straight Connector 20"/>
            <p:cNvCxnSpPr>
              <a:stCxn id="19" idx="2"/>
              <a:endCxn id="20" idx="0"/>
            </p:cNvCxnSpPr>
            <p:nvPr/>
          </p:nvCxnSpPr>
          <p:spPr>
            <a:xfrm>
              <a:off x="6416706" y="990599"/>
              <a:ext cx="8071" cy="392692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H="1">
              <a:off x="6815303" y="990601"/>
              <a:ext cx="4646" cy="39269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Rounded Rectangle 22"/>
            <p:cNvSpPr/>
            <p:nvPr/>
          </p:nvSpPr>
          <p:spPr>
            <a:xfrm rot="16200000">
              <a:off x="1879134" y="4815571"/>
              <a:ext cx="76200" cy="381002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395648" y="5103916"/>
              <a:ext cx="1148399" cy="4667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eed Reservoir and stir bar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124215" y="4631296"/>
              <a:ext cx="12192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ump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Straight Arrow Connector 25"/>
            <p:cNvCxnSpPr/>
            <p:nvPr/>
          </p:nvCxnSpPr>
          <p:spPr>
            <a:xfrm>
              <a:off x="3779456" y="4967974"/>
              <a:ext cx="30480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 flipH="1">
              <a:off x="2984853" y="2385074"/>
              <a:ext cx="30480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5302446" y="2996813"/>
              <a:ext cx="20574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s sampling port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176759" y="1501450"/>
              <a:ext cx="1524008" cy="4667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rbon rod/stainless steel wire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Straight Connector 29"/>
            <p:cNvCxnSpPr/>
            <p:nvPr/>
          </p:nvCxnSpPr>
          <p:spPr>
            <a:xfrm flipH="1" flipV="1">
              <a:off x="5029225" y="4648203"/>
              <a:ext cx="304802" cy="3810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5334026" y="4800603"/>
              <a:ext cx="1981210" cy="4667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afion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EA w/ Pt deposited carbon cathode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772710" y="685800"/>
              <a:ext cx="1628120" cy="6588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verted graduated cylinder for H</a:t>
              </a:r>
              <a:r>
                <a:rPr lang="en-US" sz="14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ollection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5031574" y="3993224"/>
              <a:ext cx="1444625" cy="267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thode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3539017" y="3843731"/>
              <a:ext cx="1339850" cy="461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iocatalytic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node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5715028" y="2438401"/>
              <a:ext cx="1905009" cy="457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Straight Connector 35"/>
            <p:cNvCxnSpPr/>
            <p:nvPr/>
          </p:nvCxnSpPr>
          <p:spPr>
            <a:xfrm flipH="1">
              <a:off x="4800623" y="1981201"/>
              <a:ext cx="76200" cy="10668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4876824" y="1981201"/>
              <a:ext cx="152401" cy="11430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2124034" y="1297539"/>
              <a:ext cx="1524008" cy="4667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g/</a:t>
              </a:r>
              <a:r>
                <a:rPr lang="en-US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gCl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ference electrode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Elbow Connector 63"/>
            <p:cNvCxnSpPr/>
            <p:nvPr/>
          </p:nvCxnSpPr>
          <p:spPr>
            <a:xfrm rot="16200000" flipV="1">
              <a:off x="3596374" y="2697085"/>
              <a:ext cx="1359420" cy="463519"/>
            </a:xfrm>
            <a:prstGeom prst="bentConnector3">
              <a:avLst>
                <a:gd name="adj1" fmla="val 96774"/>
              </a:avLst>
            </a:prstGeom>
            <a:ln w="38100">
              <a:solidFill>
                <a:srgbClr val="0070C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Elbow Connector 41"/>
            <p:cNvCxnSpPr>
              <a:stCxn id="43" idx="6"/>
            </p:cNvCxnSpPr>
            <p:nvPr/>
          </p:nvCxnSpPr>
          <p:spPr>
            <a:xfrm flipV="1">
              <a:off x="3486167" y="4410079"/>
              <a:ext cx="1193012" cy="685801"/>
            </a:xfrm>
            <a:prstGeom prst="bentConnector3">
              <a:avLst>
                <a:gd name="adj1" fmla="val 98969"/>
              </a:avLst>
            </a:prstGeom>
            <a:ln w="38100">
              <a:solidFill>
                <a:srgbClr val="0070C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Oval 42"/>
            <p:cNvSpPr/>
            <p:nvPr/>
          </p:nvSpPr>
          <p:spPr>
            <a:xfrm>
              <a:off x="3295666" y="5000629"/>
              <a:ext cx="190501" cy="1905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953024" y="3569569"/>
              <a:ext cx="76200" cy="1040534"/>
            </a:xfrm>
            <a:prstGeom prst="rect">
              <a:avLst/>
            </a:prstGeom>
            <a:pattFill prst="pct5">
              <a:fgClr>
                <a:prstClr val="black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ounded Rectangle 45"/>
            <p:cNvSpPr/>
            <p:nvPr/>
          </p:nvSpPr>
          <p:spPr>
            <a:xfrm>
              <a:off x="4405335" y="3495677"/>
              <a:ext cx="547689" cy="1152526"/>
            </a:xfrm>
            <a:prstGeom prst="roundRect">
              <a:avLst/>
            </a:prstGeom>
            <a:blipFill rotWithShape="1">
              <a:blip r:embed="rId3"/>
              <a:tile tx="0" ty="0" sx="100000" sy="100000" flip="none" algn="tl"/>
            </a:blip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Freeform 47"/>
            <p:cNvSpPr/>
            <p:nvPr/>
          </p:nvSpPr>
          <p:spPr>
            <a:xfrm>
              <a:off x="3796673" y="2026551"/>
              <a:ext cx="247651" cy="279400"/>
            </a:xfrm>
            <a:custGeom>
              <a:avLst/>
              <a:gdLst>
                <a:gd name="connsiteX0" fmla="*/ 0 w 495300"/>
                <a:gd name="connsiteY0" fmla="*/ 266700 h 279400"/>
                <a:gd name="connsiteX1" fmla="*/ 495300 w 495300"/>
                <a:gd name="connsiteY1" fmla="*/ 279400 h 279400"/>
                <a:gd name="connsiteX2" fmla="*/ 495300 w 495300"/>
                <a:gd name="connsiteY2" fmla="*/ 203200 h 279400"/>
                <a:gd name="connsiteX3" fmla="*/ 342900 w 495300"/>
                <a:gd name="connsiteY3" fmla="*/ 203200 h 279400"/>
                <a:gd name="connsiteX4" fmla="*/ 342900 w 495300"/>
                <a:gd name="connsiteY4" fmla="*/ 0 h 279400"/>
                <a:gd name="connsiteX5" fmla="*/ 190500 w 495300"/>
                <a:gd name="connsiteY5" fmla="*/ 12700 h 279400"/>
                <a:gd name="connsiteX6" fmla="*/ 190500 w 495300"/>
                <a:gd name="connsiteY6" fmla="*/ 203200 h 279400"/>
                <a:gd name="connsiteX7" fmla="*/ 12700 w 495300"/>
                <a:gd name="connsiteY7" fmla="*/ 190500 h 279400"/>
                <a:gd name="connsiteX8" fmla="*/ 0 w 495300"/>
                <a:gd name="connsiteY8" fmla="*/ 266700 h 2794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495300" h="279400">
                  <a:moveTo>
                    <a:pt x="0" y="266700"/>
                  </a:moveTo>
                  <a:lnTo>
                    <a:pt x="495300" y="279400"/>
                  </a:lnTo>
                  <a:lnTo>
                    <a:pt x="495300" y="203200"/>
                  </a:lnTo>
                  <a:lnTo>
                    <a:pt x="342900" y="203200"/>
                  </a:lnTo>
                  <a:lnTo>
                    <a:pt x="342900" y="0"/>
                  </a:lnTo>
                  <a:lnTo>
                    <a:pt x="190500" y="12700"/>
                  </a:lnTo>
                  <a:lnTo>
                    <a:pt x="190500" y="203200"/>
                  </a:lnTo>
                  <a:lnTo>
                    <a:pt x="12700" y="190500"/>
                  </a:lnTo>
                  <a:lnTo>
                    <a:pt x="0" y="266700"/>
                  </a:lnTo>
                  <a:close/>
                </a:path>
              </a:pathLst>
            </a:cu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Freeform 48"/>
            <p:cNvSpPr/>
            <p:nvPr/>
          </p:nvSpPr>
          <p:spPr>
            <a:xfrm>
              <a:off x="2006610" y="3035302"/>
              <a:ext cx="1295407" cy="2070102"/>
            </a:xfrm>
            <a:custGeom>
              <a:avLst/>
              <a:gdLst>
                <a:gd name="connsiteX0" fmla="*/ 1295400 w 1295400"/>
                <a:gd name="connsiteY0" fmla="*/ 2070100 h 2070100"/>
                <a:gd name="connsiteX1" fmla="*/ 1079500 w 1295400"/>
                <a:gd name="connsiteY1" fmla="*/ 2070100 h 2070100"/>
                <a:gd name="connsiteX2" fmla="*/ 1079500 w 1295400"/>
                <a:gd name="connsiteY2" fmla="*/ 0 h 2070100"/>
                <a:gd name="connsiteX3" fmla="*/ 12700 w 1295400"/>
                <a:gd name="connsiteY3" fmla="*/ 0 h 2070100"/>
                <a:gd name="connsiteX4" fmla="*/ 0 w 1295400"/>
                <a:gd name="connsiteY4" fmla="*/ 1447800 h 20701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295400" h="2070100">
                  <a:moveTo>
                    <a:pt x="1295400" y="2070100"/>
                  </a:moveTo>
                  <a:lnTo>
                    <a:pt x="1079500" y="2070100"/>
                  </a:lnTo>
                  <a:lnTo>
                    <a:pt x="1079500" y="0"/>
                  </a:lnTo>
                  <a:lnTo>
                    <a:pt x="12700" y="0"/>
                  </a:lnTo>
                  <a:lnTo>
                    <a:pt x="0" y="1447800"/>
                  </a:lnTo>
                </a:path>
              </a:pathLst>
            </a:custGeom>
            <a:noFill/>
            <a:ln w="381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Straight Arrow Connector 49"/>
            <p:cNvCxnSpPr/>
            <p:nvPr/>
          </p:nvCxnSpPr>
          <p:spPr>
            <a:xfrm flipV="1">
              <a:off x="2006610" y="4070352"/>
              <a:ext cx="0" cy="125115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>
              <a:off x="1792151" y="4037524"/>
              <a:ext cx="0" cy="456911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1528075" y="4290593"/>
              <a:ext cx="8128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5181624" y="2209801"/>
              <a:ext cx="0" cy="1281547"/>
            </a:xfrm>
            <a:prstGeom prst="line">
              <a:avLst/>
            </a:prstGeom>
            <a:ln w="3810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Elbow Connector 56"/>
            <p:cNvCxnSpPr/>
            <p:nvPr/>
          </p:nvCxnSpPr>
          <p:spPr>
            <a:xfrm rot="5400000" flipH="1" flipV="1">
              <a:off x="4762500" y="3467100"/>
              <a:ext cx="609600" cy="76200"/>
            </a:xfrm>
            <a:prstGeom prst="bentConnector3">
              <a:avLst>
                <a:gd name="adj1" fmla="val -694"/>
              </a:avLst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" name="Straight Connector 2"/>
          <p:cNvCxnSpPr/>
          <p:nvPr/>
        </p:nvCxnSpPr>
        <p:spPr>
          <a:xfrm>
            <a:off x="2893346" y="1108939"/>
            <a:ext cx="1013720" cy="2474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Freeform 66"/>
          <p:cNvSpPr/>
          <p:nvPr/>
        </p:nvSpPr>
        <p:spPr>
          <a:xfrm rot="5400000">
            <a:off x="5791990" y="2868152"/>
            <a:ext cx="284988" cy="339884"/>
          </a:xfrm>
          <a:custGeom>
            <a:avLst/>
            <a:gdLst>
              <a:gd name="connsiteX0" fmla="*/ 0 w 495300"/>
              <a:gd name="connsiteY0" fmla="*/ 266700 h 279400"/>
              <a:gd name="connsiteX1" fmla="*/ 495300 w 495300"/>
              <a:gd name="connsiteY1" fmla="*/ 279400 h 279400"/>
              <a:gd name="connsiteX2" fmla="*/ 495300 w 495300"/>
              <a:gd name="connsiteY2" fmla="*/ 203200 h 279400"/>
              <a:gd name="connsiteX3" fmla="*/ 342900 w 495300"/>
              <a:gd name="connsiteY3" fmla="*/ 203200 h 279400"/>
              <a:gd name="connsiteX4" fmla="*/ 342900 w 495300"/>
              <a:gd name="connsiteY4" fmla="*/ 0 h 279400"/>
              <a:gd name="connsiteX5" fmla="*/ 190500 w 495300"/>
              <a:gd name="connsiteY5" fmla="*/ 12700 h 279400"/>
              <a:gd name="connsiteX6" fmla="*/ 190500 w 495300"/>
              <a:gd name="connsiteY6" fmla="*/ 203200 h 279400"/>
              <a:gd name="connsiteX7" fmla="*/ 12700 w 495300"/>
              <a:gd name="connsiteY7" fmla="*/ 190500 h 279400"/>
              <a:gd name="connsiteX8" fmla="*/ 0 w 495300"/>
              <a:gd name="connsiteY8" fmla="*/ 266700 h 279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495300" h="279400">
                <a:moveTo>
                  <a:pt x="0" y="266700"/>
                </a:moveTo>
                <a:lnTo>
                  <a:pt x="495300" y="279400"/>
                </a:lnTo>
                <a:lnTo>
                  <a:pt x="495300" y="203200"/>
                </a:lnTo>
                <a:lnTo>
                  <a:pt x="342900" y="203200"/>
                </a:lnTo>
                <a:lnTo>
                  <a:pt x="342900" y="0"/>
                </a:lnTo>
                <a:lnTo>
                  <a:pt x="190500" y="12700"/>
                </a:lnTo>
                <a:lnTo>
                  <a:pt x="190500" y="203200"/>
                </a:lnTo>
                <a:lnTo>
                  <a:pt x="12700" y="190500"/>
                </a:lnTo>
                <a:lnTo>
                  <a:pt x="0" y="266700"/>
                </a:lnTo>
                <a:close/>
              </a:path>
            </a:pathLst>
          </a:cu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Elbow Connector 3"/>
          <p:cNvCxnSpPr>
            <a:endCxn id="48" idx="0"/>
          </p:cNvCxnSpPr>
          <p:nvPr/>
        </p:nvCxnSpPr>
        <p:spPr>
          <a:xfrm flipV="1">
            <a:off x="1405015" y="1890762"/>
            <a:ext cx="2502051" cy="2014090"/>
          </a:xfrm>
          <a:prstGeom prst="bentConnector3">
            <a:avLst>
              <a:gd name="adj1" fmla="val 69"/>
            </a:avLst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flipV="1">
            <a:off x="1074274" y="3873641"/>
            <a:ext cx="269596" cy="25627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V="1">
            <a:off x="1343870" y="3517702"/>
            <a:ext cx="0" cy="35593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1343870" y="3517702"/>
            <a:ext cx="49161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1835486" y="3517702"/>
            <a:ext cx="0" cy="37017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1835486" y="3898498"/>
            <a:ext cx="253737" cy="2314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Round Same Side Corner Rectangle 87"/>
          <p:cNvSpPr/>
          <p:nvPr/>
        </p:nvSpPr>
        <p:spPr>
          <a:xfrm rot="10800000">
            <a:off x="5454294" y="3505201"/>
            <a:ext cx="666061" cy="1041682"/>
          </a:xfrm>
          <a:prstGeom prst="round2Same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TextBox 88"/>
          <p:cNvSpPr txBox="1"/>
          <p:nvPr/>
        </p:nvSpPr>
        <p:spPr>
          <a:xfrm>
            <a:off x="1792477" y="2895600"/>
            <a:ext cx="11008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itrogen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arger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Connector 89"/>
          <p:cNvCxnSpPr/>
          <p:nvPr/>
        </p:nvCxnSpPr>
        <p:spPr>
          <a:xfrm flipV="1">
            <a:off x="1560210" y="3194532"/>
            <a:ext cx="304773" cy="1270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85748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76200" y="5715000"/>
            <a:ext cx="9982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Table S1:  Calculation of the </a:t>
            </a:r>
            <a:r>
              <a:rPr lang="en-US" b="1" dirty="0"/>
              <a:t>electrons liberated </a:t>
            </a:r>
            <a:r>
              <a:rPr lang="en-US" b="1" dirty="0" smtClean="0"/>
              <a:t>through the </a:t>
            </a:r>
            <a:r>
              <a:rPr lang="en-US" b="1" dirty="0"/>
              <a:t>theoretical conversion of 1 </a:t>
            </a:r>
            <a:r>
              <a:rPr lang="en-US" b="1" dirty="0" err="1"/>
              <a:t>mol</a:t>
            </a:r>
            <a:r>
              <a:rPr lang="en-US" b="1" dirty="0"/>
              <a:t> of </a:t>
            </a:r>
            <a:r>
              <a:rPr lang="en-US" b="1" dirty="0" smtClean="0"/>
              <a:t>compound/COD </a:t>
            </a:r>
            <a:r>
              <a:rPr lang="en-US" b="1" dirty="0"/>
              <a:t>to 1 </a:t>
            </a:r>
            <a:r>
              <a:rPr lang="en-US" b="1" dirty="0" err="1"/>
              <a:t>mol</a:t>
            </a:r>
            <a:r>
              <a:rPr lang="en-US" b="1" dirty="0"/>
              <a:t> of acetic </a:t>
            </a:r>
            <a:r>
              <a:rPr lang="en-US" b="1" dirty="0" smtClean="0"/>
              <a:t>acid.</a:t>
            </a:r>
          </a:p>
          <a:p>
            <a:endParaRPr lang="en-US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3331881"/>
              </p:ext>
            </p:extLst>
          </p:nvPr>
        </p:nvGraphicFramePr>
        <p:xfrm>
          <a:off x="2165350" y="2139156"/>
          <a:ext cx="4813300" cy="351091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879600"/>
                <a:gridCol w="29337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u="none" strike="noStrike" dirty="0">
                          <a:effectLst/>
                        </a:rPr>
                        <a:t>Compound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u="none" strike="noStrike" dirty="0">
                          <a:effectLst/>
                        </a:rPr>
                        <a:t>Conversion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3619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1" u="none" strike="noStrike" dirty="0" err="1">
                          <a:effectLst/>
                        </a:rPr>
                        <a:t>Levoglucosan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1400" u="none" strike="noStrike" dirty="0">
                          <a:effectLst/>
                        </a:rPr>
                        <a:t>C</a:t>
                      </a:r>
                      <a:r>
                        <a:rPr lang="pt-BR" sz="1400" u="none" strike="noStrike" baseline="-25000" dirty="0">
                          <a:effectLst/>
                        </a:rPr>
                        <a:t>6</a:t>
                      </a:r>
                      <a:r>
                        <a:rPr lang="pt-BR" sz="1400" u="none" strike="noStrike" dirty="0">
                          <a:effectLst/>
                        </a:rPr>
                        <a:t>H</a:t>
                      </a:r>
                      <a:r>
                        <a:rPr lang="pt-BR" sz="1400" u="none" strike="noStrike" baseline="-25000" dirty="0">
                          <a:effectLst/>
                        </a:rPr>
                        <a:t>10</a:t>
                      </a:r>
                      <a:r>
                        <a:rPr lang="pt-BR" sz="1400" u="none" strike="noStrike" dirty="0">
                          <a:effectLst/>
                        </a:rPr>
                        <a:t>O</a:t>
                      </a:r>
                      <a:r>
                        <a:rPr lang="pt-BR" sz="1400" u="none" strike="noStrike" baseline="-25000" dirty="0">
                          <a:effectLst/>
                        </a:rPr>
                        <a:t>5</a:t>
                      </a:r>
                      <a:r>
                        <a:rPr lang="pt-BR" sz="1400" u="none" strike="noStrike" dirty="0">
                          <a:effectLst/>
                        </a:rPr>
                        <a:t> + 7H</a:t>
                      </a:r>
                      <a:r>
                        <a:rPr lang="pt-BR" sz="1400" u="none" strike="noStrike" baseline="-25000" dirty="0">
                          <a:effectLst/>
                        </a:rPr>
                        <a:t>2</a:t>
                      </a:r>
                      <a:r>
                        <a:rPr lang="pt-BR" sz="1400" u="none" strike="noStrike" dirty="0">
                          <a:effectLst/>
                        </a:rPr>
                        <a:t>O = 6CO</a:t>
                      </a:r>
                      <a:r>
                        <a:rPr lang="pt-BR" sz="1400" u="none" strike="noStrike" baseline="-25000" dirty="0">
                          <a:effectLst/>
                        </a:rPr>
                        <a:t>2</a:t>
                      </a:r>
                      <a:r>
                        <a:rPr lang="pt-BR" sz="1400" u="none" strike="noStrike" dirty="0">
                          <a:effectLst/>
                        </a:rPr>
                        <a:t> + 24H</a:t>
                      </a:r>
                      <a:r>
                        <a:rPr lang="pt-BR" sz="1400" u="none" strike="noStrike" baseline="30000" dirty="0">
                          <a:effectLst/>
                        </a:rPr>
                        <a:t>+</a:t>
                      </a:r>
                      <a:r>
                        <a:rPr lang="pt-BR" sz="1400" u="none" strike="noStrike" dirty="0">
                          <a:effectLst/>
                        </a:rPr>
                        <a:t> + 24e</a:t>
                      </a:r>
                      <a:r>
                        <a:rPr lang="pt-BR" sz="1400" u="none" strike="noStrike" baseline="30000" dirty="0">
                          <a:effectLst/>
                        </a:rPr>
                        <a:t>-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3619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1" u="none" strike="noStrike" dirty="0">
                          <a:effectLst/>
                        </a:rPr>
                        <a:t>Acetic acid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400" u="none" strike="noStrike" dirty="0">
                          <a:effectLst/>
                        </a:rPr>
                        <a:t>C2H4O2 + 2H2O = 2CO2 + 8H + 8e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3619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1" u="none" strike="noStrike" dirty="0">
                          <a:effectLst/>
                        </a:rPr>
                        <a:t>Propionic acid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1400" u="none" strike="noStrike" dirty="0">
                          <a:effectLst/>
                        </a:rPr>
                        <a:t>C</a:t>
                      </a:r>
                      <a:r>
                        <a:rPr lang="pt-BR" sz="1400" u="none" strike="noStrike" baseline="-25000" dirty="0">
                          <a:effectLst/>
                        </a:rPr>
                        <a:t>3</a:t>
                      </a:r>
                      <a:r>
                        <a:rPr lang="pt-BR" sz="1400" u="none" strike="noStrike" dirty="0">
                          <a:effectLst/>
                        </a:rPr>
                        <a:t>H</a:t>
                      </a:r>
                      <a:r>
                        <a:rPr lang="pt-BR" sz="1400" u="none" strike="noStrike" baseline="-25000" dirty="0">
                          <a:effectLst/>
                        </a:rPr>
                        <a:t>6</a:t>
                      </a:r>
                      <a:r>
                        <a:rPr lang="pt-BR" sz="1400" u="none" strike="noStrike" dirty="0">
                          <a:effectLst/>
                        </a:rPr>
                        <a:t>O2 + 4H</a:t>
                      </a:r>
                      <a:r>
                        <a:rPr lang="pt-BR" sz="1400" u="none" strike="noStrike" baseline="-25000" dirty="0">
                          <a:effectLst/>
                        </a:rPr>
                        <a:t>2</a:t>
                      </a:r>
                      <a:r>
                        <a:rPr lang="pt-BR" sz="1400" u="none" strike="noStrike" dirty="0">
                          <a:effectLst/>
                        </a:rPr>
                        <a:t>O = 3CO</a:t>
                      </a:r>
                      <a:r>
                        <a:rPr lang="pt-BR" sz="1400" u="none" strike="noStrike" baseline="-25000" dirty="0">
                          <a:effectLst/>
                        </a:rPr>
                        <a:t>2</a:t>
                      </a:r>
                      <a:r>
                        <a:rPr lang="pt-BR" sz="1400" u="none" strike="noStrike" dirty="0">
                          <a:effectLst/>
                        </a:rPr>
                        <a:t> + 14H</a:t>
                      </a:r>
                      <a:r>
                        <a:rPr lang="pt-BR" sz="1400" u="none" strike="noStrike" baseline="30000" dirty="0">
                          <a:effectLst/>
                        </a:rPr>
                        <a:t>+ </a:t>
                      </a:r>
                      <a:r>
                        <a:rPr lang="pt-BR" sz="1400" u="none" strike="noStrike" dirty="0">
                          <a:effectLst/>
                        </a:rPr>
                        <a:t>+ 14e</a:t>
                      </a:r>
                      <a:r>
                        <a:rPr lang="pt-BR" sz="1400" u="none" strike="noStrike" baseline="30000" dirty="0">
                          <a:effectLst/>
                        </a:rPr>
                        <a:t>-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3619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1" u="none" strike="noStrike" dirty="0">
                          <a:effectLst/>
                        </a:rPr>
                        <a:t>HMF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1400" u="none" strike="noStrike">
                          <a:effectLst/>
                        </a:rPr>
                        <a:t>C</a:t>
                      </a:r>
                      <a:r>
                        <a:rPr lang="pt-BR" sz="1400" u="none" strike="noStrike" baseline="-25000">
                          <a:effectLst/>
                        </a:rPr>
                        <a:t>6</a:t>
                      </a:r>
                      <a:r>
                        <a:rPr lang="pt-BR" sz="1400" u="none" strike="noStrike">
                          <a:effectLst/>
                        </a:rPr>
                        <a:t>H</a:t>
                      </a:r>
                      <a:r>
                        <a:rPr lang="pt-BR" sz="1400" u="none" strike="noStrike" baseline="-25000">
                          <a:effectLst/>
                        </a:rPr>
                        <a:t>6</a:t>
                      </a:r>
                      <a:r>
                        <a:rPr lang="pt-BR" sz="1400" u="none" strike="noStrike">
                          <a:effectLst/>
                        </a:rPr>
                        <a:t>O</a:t>
                      </a:r>
                      <a:r>
                        <a:rPr lang="pt-BR" sz="1400" u="none" strike="noStrike" baseline="-25000">
                          <a:effectLst/>
                        </a:rPr>
                        <a:t>3</a:t>
                      </a:r>
                      <a:r>
                        <a:rPr lang="pt-BR" sz="1400" u="none" strike="noStrike">
                          <a:effectLst/>
                        </a:rPr>
                        <a:t> + 9H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O = 6CO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 + 24H</a:t>
                      </a:r>
                      <a:r>
                        <a:rPr lang="pt-BR" sz="1400" u="none" strike="noStrike" baseline="30000">
                          <a:effectLst/>
                        </a:rPr>
                        <a:t>+</a:t>
                      </a:r>
                      <a:r>
                        <a:rPr lang="pt-BR" sz="1400" u="none" strike="noStrike">
                          <a:effectLst/>
                        </a:rPr>
                        <a:t> + 24e</a:t>
                      </a:r>
                      <a:r>
                        <a:rPr lang="pt-BR" sz="1400" u="none" strike="noStrike" baseline="30000">
                          <a:effectLst/>
                        </a:rPr>
                        <a:t>-</a:t>
                      </a:r>
                      <a:endParaRPr lang="pt-BR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3619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1" u="none" strike="noStrike" dirty="0">
                          <a:effectLst/>
                        </a:rPr>
                        <a:t>2(5H)-</a:t>
                      </a:r>
                      <a:r>
                        <a:rPr lang="en-US" sz="1600" b="1" u="none" strike="noStrike" dirty="0" err="1">
                          <a:effectLst/>
                        </a:rPr>
                        <a:t>Furanone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1400" u="none" strike="noStrike">
                          <a:effectLst/>
                        </a:rPr>
                        <a:t>C</a:t>
                      </a:r>
                      <a:r>
                        <a:rPr lang="pt-BR" sz="1400" u="none" strike="noStrike" baseline="-25000">
                          <a:effectLst/>
                        </a:rPr>
                        <a:t>4</a:t>
                      </a:r>
                      <a:r>
                        <a:rPr lang="pt-BR" sz="1400" u="none" strike="noStrike">
                          <a:effectLst/>
                        </a:rPr>
                        <a:t>H</a:t>
                      </a:r>
                      <a:r>
                        <a:rPr lang="pt-BR" sz="1400" u="none" strike="noStrike" baseline="-25000">
                          <a:effectLst/>
                        </a:rPr>
                        <a:t>4</a:t>
                      </a:r>
                      <a:r>
                        <a:rPr lang="pt-BR" sz="1400" u="none" strike="noStrike">
                          <a:effectLst/>
                        </a:rPr>
                        <a:t>O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 + 6H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O = 4CO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 + 16H</a:t>
                      </a:r>
                      <a:r>
                        <a:rPr lang="pt-BR" sz="1400" u="none" strike="noStrike" baseline="30000">
                          <a:effectLst/>
                        </a:rPr>
                        <a:t>+</a:t>
                      </a:r>
                      <a:r>
                        <a:rPr lang="pt-BR" sz="1400" u="none" strike="noStrike">
                          <a:effectLst/>
                        </a:rPr>
                        <a:t> + 16e</a:t>
                      </a:r>
                      <a:r>
                        <a:rPr lang="pt-BR" sz="1400" u="none" strike="noStrike" baseline="30000">
                          <a:effectLst/>
                        </a:rPr>
                        <a:t>-</a:t>
                      </a:r>
                      <a:endParaRPr lang="pt-BR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3619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1" u="none" strike="noStrike" dirty="0">
                          <a:effectLst/>
                        </a:rPr>
                        <a:t>Catechol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1400" u="none" strike="noStrike">
                          <a:effectLst/>
                        </a:rPr>
                        <a:t>C</a:t>
                      </a:r>
                      <a:r>
                        <a:rPr lang="pt-BR" sz="1400" u="none" strike="noStrike" baseline="-25000">
                          <a:effectLst/>
                        </a:rPr>
                        <a:t>6</a:t>
                      </a:r>
                      <a:r>
                        <a:rPr lang="pt-BR" sz="1400" u="none" strike="noStrike">
                          <a:effectLst/>
                        </a:rPr>
                        <a:t>H</a:t>
                      </a:r>
                      <a:r>
                        <a:rPr lang="pt-BR" sz="1400" u="none" strike="noStrike" baseline="-25000">
                          <a:effectLst/>
                        </a:rPr>
                        <a:t>6</a:t>
                      </a:r>
                      <a:r>
                        <a:rPr lang="pt-BR" sz="1400" u="none" strike="noStrike">
                          <a:effectLst/>
                        </a:rPr>
                        <a:t>O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 + 10H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O = 6CO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 + 26H</a:t>
                      </a:r>
                      <a:r>
                        <a:rPr lang="pt-BR" sz="1400" u="none" strike="noStrike" baseline="30000">
                          <a:effectLst/>
                        </a:rPr>
                        <a:t>+</a:t>
                      </a:r>
                      <a:r>
                        <a:rPr lang="pt-BR" sz="1400" u="none" strike="noStrike">
                          <a:effectLst/>
                        </a:rPr>
                        <a:t> + 26e</a:t>
                      </a:r>
                      <a:r>
                        <a:rPr lang="pt-BR" sz="1400" u="none" strike="noStrike" baseline="30000">
                          <a:effectLst/>
                        </a:rPr>
                        <a:t>-</a:t>
                      </a:r>
                      <a:endParaRPr lang="pt-BR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3619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1" u="none" strike="noStrike" dirty="0">
                          <a:effectLst/>
                        </a:rPr>
                        <a:t>Furfural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1400" u="none" strike="noStrike">
                          <a:effectLst/>
                        </a:rPr>
                        <a:t>C</a:t>
                      </a:r>
                      <a:r>
                        <a:rPr lang="pt-BR" sz="1400" u="none" strike="noStrike" baseline="-25000">
                          <a:effectLst/>
                        </a:rPr>
                        <a:t>5</a:t>
                      </a:r>
                      <a:r>
                        <a:rPr lang="pt-BR" sz="1400" u="none" strike="noStrike">
                          <a:effectLst/>
                        </a:rPr>
                        <a:t>H</a:t>
                      </a:r>
                      <a:r>
                        <a:rPr lang="pt-BR" sz="1400" u="none" strike="noStrike" baseline="-25000">
                          <a:effectLst/>
                        </a:rPr>
                        <a:t>4</a:t>
                      </a:r>
                      <a:r>
                        <a:rPr lang="pt-BR" sz="1400" u="none" strike="noStrike">
                          <a:effectLst/>
                        </a:rPr>
                        <a:t>O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 + 8H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O = 5CO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 + 20H</a:t>
                      </a:r>
                      <a:r>
                        <a:rPr lang="pt-BR" sz="1400" u="none" strike="noStrike" baseline="30000">
                          <a:effectLst/>
                        </a:rPr>
                        <a:t>+</a:t>
                      </a:r>
                      <a:r>
                        <a:rPr lang="pt-BR" sz="1400" u="none" strike="noStrike">
                          <a:effectLst/>
                        </a:rPr>
                        <a:t> + 20e</a:t>
                      </a:r>
                      <a:r>
                        <a:rPr lang="pt-BR" sz="1400" u="none" strike="noStrike" baseline="30000">
                          <a:effectLst/>
                        </a:rPr>
                        <a:t>-</a:t>
                      </a:r>
                      <a:endParaRPr lang="pt-BR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3619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1" u="none" strike="noStrike" dirty="0">
                          <a:effectLst/>
                        </a:rPr>
                        <a:t>Phenol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1400" u="none" strike="noStrike">
                          <a:effectLst/>
                        </a:rPr>
                        <a:t>C</a:t>
                      </a:r>
                      <a:r>
                        <a:rPr lang="pt-BR" sz="1400" u="none" strike="noStrike" baseline="-25000">
                          <a:effectLst/>
                        </a:rPr>
                        <a:t>6</a:t>
                      </a:r>
                      <a:r>
                        <a:rPr lang="pt-BR" sz="1400" u="none" strike="noStrike">
                          <a:effectLst/>
                        </a:rPr>
                        <a:t>H</a:t>
                      </a:r>
                      <a:r>
                        <a:rPr lang="pt-BR" sz="1400" u="none" strike="noStrike" baseline="-25000">
                          <a:effectLst/>
                        </a:rPr>
                        <a:t>6</a:t>
                      </a:r>
                      <a:r>
                        <a:rPr lang="pt-BR" sz="1400" u="none" strike="noStrike">
                          <a:effectLst/>
                        </a:rPr>
                        <a:t>O + 11H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O = 6CO</a:t>
                      </a:r>
                      <a:r>
                        <a:rPr lang="pt-BR" sz="1400" u="none" strike="noStrike" baseline="-25000">
                          <a:effectLst/>
                        </a:rPr>
                        <a:t>2</a:t>
                      </a:r>
                      <a:r>
                        <a:rPr lang="pt-BR" sz="1400" u="none" strike="noStrike">
                          <a:effectLst/>
                        </a:rPr>
                        <a:t> + 27H</a:t>
                      </a:r>
                      <a:r>
                        <a:rPr lang="pt-BR" sz="1400" u="none" strike="noStrike" baseline="30000">
                          <a:effectLst/>
                        </a:rPr>
                        <a:t>+</a:t>
                      </a:r>
                      <a:r>
                        <a:rPr lang="pt-BR" sz="1400" u="none" strike="noStrike">
                          <a:effectLst/>
                        </a:rPr>
                        <a:t> + 27e</a:t>
                      </a:r>
                      <a:r>
                        <a:rPr lang="pt-BR" sz="1400" u="none" strike="noStrike" baseline="30000">
                          <a:effectLst/>
                        </a:rPr>
                        <a:t>-</a:t>
                      </a:r>
                      <a:endParaRPr lang="pt-BR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3619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2000" b="1" u="none" strike="noStrike" dirty="0">
                          <a:effectLst/>
                        </a:rPr>
                        <a:t>COD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1400" u="none" strike="noStrike" dirty="0">
                          <a:effectLst/>
                        </a:rPr>
                        <a:t>CH</a:t>
                      </a:r>
                      <a:r>
                        <a:rPr lang="pt-BR" sz="1400" u="none" strike="noStrike" baseline="-25000" dirty="0">
                          <a:effectLst/>
                        </a:rPr>
                        <a:t>2</a:t>
                      </a:r>
                      <a:r>
                        <a:rPr lang="pt-BR" sz="1400" u="none" strike="noStrike" dirty="0">
                          <a:effectLst/>
                        </a:rPr>
                        <a:t>O + H</a:t>
                      </a:r>
                      <a:r>
                        <a:rPr lang="pt-BR" sz="1400" u="none" strike="noStrike" baseline="-25000" dirty="0">
                          <a:effectLst/>
                        </a:rPr>
                        <a:t>2</a:t>
                      </a:r>
                      <a:r>
                        <a:rPr lang="pt-BR" sz="1400" u="none" strike="noStrike" dirty="0">
                          <a:effectLst/>
                        </a:rPr>
                        <a:t>O = CO</a:t>
                      </a:r>
                      <a:r>
                        <a:rPr lang="pt-BR" sz="1400" u="none" strike="noStrike" baseline="-25000" dirty="0">
                          <a:effectLst/>
                        </a:rPr>
                        <a:t>2</a:t>
                      </a:r>
                      <a:r>
                        <a:rPr lang="pt-BR" sz="1400" u="none" strike="noStrike" dirty="0">
                          <a:effectLst/>
                        </a:rPr>
                        <a:t> + 4H</a:t>
                      </a:r>
                      <a:r>
                        <a:rPr lang="pt-BR" sz="1400" u="none" strike="noStrike" baseline="30000" dirty="0">
                          <a:effectLst/>
                        </a:rPr>
                        <a:t>+</a:t>
                      </a:r>
                      <a:r>
                        <a:rPr lang="pt-BR" sz="1400" u="none" strike="noStrike" dirty="0">
                          <a:effectLst/>
                        </a:rPr>
                        <a:t> + 4e</a:t>
                      </a:r>
                      <a:r>
                        <a:rPr lang="pt-BR" sz="1400" u="none" strike="noStrike" baseline="30000" dirty="0">
                          <a:effectLst/>
                        </a:rPr>
                        <a:t>-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778090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38200" y="4419600"/>
            <a:ext cx="9239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Table S2:  Cumulative hydrogen production from each batch experiment.</a:t>
            </a:r>
          </a:p>
          <a:p>
            <a:endParaRPr lang="en-US" dirty="0"/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0383997"/>
              </p:ext>
            </p:extLst>
          </p:nvPr>
        </p:nvGraphicFramePr>
        <p:xfrm>
          <a:off x="1752599" y="1752599"/>
          <a:ext cx="4509946" cy="2492534"/>
        </p:xfrm>
        <a:graphic>
          <a:graphicData uri="http://schemas.openxmlformats.org/drawingml/2006/table">
            <a:tbl>
              <a:tblPr/>
              <a:tblGrid>
                <a:gridCol w="977328"/>
                <a:gridCol w="966931"/>
                <a:gridCol w="966931"/>
                <a:gridCol w="631825"/>
                <a:gridCol w="966931"/>
              </a:tblGrid>
              <a:tr h="518198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im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C-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C-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518198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 g/L A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5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18198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 g/L A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8.2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 5.7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8.8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 7.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37940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 g/L BOAP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 </a:t>
                      </a:r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5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2.8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 11.8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577452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5975866"/>
            <a:ext cx="8458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2: Efficiency </a:t>
            </a:r>
            <a:r>
              <a:rPr lang="en-US" b="1" dirty="0"/>
              <a:t>during batch experiments with BOAP and acetic acid as </a:t>
            </a:r>
            <a:r>
              <a:rPr lang="en-US" b="1" dirty="0" smtClean="0"/>
              <a:t>substrate for entire runs. </a:t>
            </a:r>
            <a:endParaRPr lang="en-US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4638" y="1490663"/>
            <a:ext cx="6053137" cy="3883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918064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5975866"/>
            <a:ext cx="845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3: Hydrogen productivity during comparing run before and after acetic acid use.</a:t>
            </a:r>
            <a:endParaRPr lang="en-US" b="1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7113" y="1106488"/>
            <a:ext cx="7089775" cy="4651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98847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09600" y="4419600"/>
            <a:ext cx="9448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</a:t>
            </a:r>
            <a:r>
              <a:rPr lang="en-US" b="1" dirty="0" smtClean="0"/>
              <a:t>able S3:  Acetic acid and COD removal rates for each batch experiment.</a:t>
            </a:r>
          </a:p>
          <a:p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9081257"/>
              </p:ext>
            </p:extLst>
          </p:nvPr>
        </p:nvGraphicFramePr>
        <p:xfrm>
          <a:off x="457202" y="3528645"/>
          <a:ext cx="8229596" cy="764972"/>
        </p:xfrm>
        <a:graphic>
          <a:graphicData uri="http://schemas.openxmlformats.org/drawingml/2006/table">
            <a:tbl>
              <a:tblPr/>
              <a:tblGrid>
                <a:gridCol w="889687"/>
                <a:gridCol w="809059"/>
                <a:gridCol w="725650"/>
                <a:gridCol w="725650"/>
                <a:gridCol w="725650"/>
                <a:gridCol w="725650"/>
                <a:gridCol w="725650"/>
                <a:gridCol w="725650"/>
                <a:gridCol w="725650"/>
                <a:gridCol w="725650"/>
                <a:gridCol w="725650"/>
              </a:tblGrid>
              <a:tr h="1672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ime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72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 g/L AA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89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60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72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 g/L AA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.32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8.11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3.01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8.10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.62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1.15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3.10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2.02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4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0.96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2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 g/L BOAP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43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01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.43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42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9</a:t>
                      </a:r>
                    </a:p>
                  </a:txBody>
                  <a:tcPr marL="8363" marR="8363" marT="83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363" marR="8363" marT="836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456913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7200" y="57912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4: 16S r RNA-based </a:t>
            </a:r>
            <a:r>
              <a:rPr lang="en-US" b="1" dirty="0" err="1" smtClean="0"/>
              <a:t>taxanomical</a:t>
            </a:r>
            <a:r>
              <a:rPr lang="en-US" b="1" dirty="0" smtClean="0"/>
              <a:t> classification to the family level </a:t>
            </a:r>
            <a:r>
              <a:rPr lang="en-US" b="1" dirty="0"/>
              <a:t>for batch BOAP vs acetic acid. Numbers 1,2 indicate samples from beginning (1) and end (2) of each batch series</a:t>
            </a:r>
            <a:r>
              <a:rPr lang="en-US" b="1" dirty="0" smtClean="0"/>
              <a:t>.</a:t>
            </a:r>
            <a:endParaRPr lang="en-US" b="1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2688" y="322262"/>
            <a:ext cx="6778625" cy="53165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635682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1444499" y="1549750"/>
          <a:ext cx="6255001" cy="4626864"/>
        </p:xfrm>
        <a:graphic>
          <a:graphicData uri="http://schemas.openxmlformats.org/drawingml/2006/table">
            <a:tbl>
              <a:tblPr firstRow="1" firstCol="1" bandRow="1"/>
              <a:tblGrid>
                <a:gridCol w="2224065"/>
                <a:gridCol w="2224065"/>
                <a:gridCol w="1806871"/>
              </a:tblGrid>
              <a:tr h="41145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Quantification method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ajor chemicals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ncentration based on aqueous phase (g/L)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5726">
                <a:tc rowSpan="9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HPLC-PD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Furfural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01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,2-benzendiol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77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henol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8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Levoglucosan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5.33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cetic acid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.96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roponic acid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89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Vanillic acid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.69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HMF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5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otal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6.99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5726">
                <a:tc rowSpan="10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C-FID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henol, 2-methoxy- 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25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-methyl-4-methyphenol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07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yclohexanon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07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-methyl-1,2-cyclophetandiol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46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,6-Dimethoxyphenol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26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,3-propanediol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8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-ethylphenol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56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(5H)-Furanon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17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hydroxybutanon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35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57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otal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.02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572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>
                        <a:effectLst/>
                        <a:latin typeface="Calibri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Sum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3.01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7084" marR="670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1295400" y="628471"/>
            <a:ext cx="6634219" cy="1200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able S4</a:t>
            </a:r>
            <a:r>
              <a: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Concentrations of major chemical compounds in bio-oil aqueous phase quantified by HPLC-PDA and GC-FID.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2392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32</TotalTime>
  <Words>463</Words>
  <Application>Microsoft Office PowerPoint</Application>
  <PresentationFormat>On-screen Show (4:3)</PresentationFormat>
  <Paragraphs>144</Paragraphs>
  <Slides>8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RN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J. Biochemical Engineering</dc:title>
  <dc:creator>Borole, Abhijeet P.</dc:creator>
  <cp:lastModifiedBy>Borole, Abhijeet P.</cp:lastModifiedBy>
  <cp:revision>231</cp:revision>
  <dcterms:created xsi:type="dcterms:W3CDTF">2015-12-12T13:10:40Z</dcterms:created>
  <dcterms:modified xsi:type="dcterms:W3CDTF">2017-06-12T21:42:31Z</dcterms:modified>
</cp:coreProperties>
</file>